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FFC000"/>
    <a:srgbClr val="FF8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4" autoAdjust="0"/>
    <p:restoredTop sz="94660"/>
  </p:normalViewPr>
  <p:slideViewPr>
    <p:cSldViewPr snapToGrid="0">
      <p:cViewPr varScale="1">
        <p:scale>
          <a:sx n="79" d="100"/>
          <a:sy n="79" d="100"/>
        </p:scale>
        <p:origin x="85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75F735-0ECE-11E7-3D2F-B8DF244566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172073E-A8E1-9A5F-89ED-F94A79A0DD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D8A9470-112A-29CC-7336-631EBA971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E5520A4-799F-FAC5-1367-76BB525F3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B573C5-C4C0-62BD-867C-33C62CC476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055655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A4EBCCD-E080-1EEB-8BA4-DA20F9B3AE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56295A6-48DD-B196-AE5A-04F26CEFF9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8A66DBA-1E0A-EA2C-DEB4-4255E83022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8F99831-1CBB-6A2D-707A-E9903C0B63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9FDF4F7-F2C6-E5B4-8182-85F14908A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082725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01A639E-ACAD-C6C1-5C37-056117E95E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BBD5093-1818-5BE2-B3BF-037465F7FA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3CB5AC6-BAE2-4C81-4159-9C5C5BA68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97BAACB-30F7-878D-8E5C-0B23FF3197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5945D48-2238-F86F-99EC-032EF147B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34641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F447FAD-FA69-F532-D7DA-DE0C8501B0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0D46A74-EE4A-37F7-0CA7-7C1768FE3D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E01271-4CC1-3B0A-FB29-C4CE7092E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15ADAA8-57B9-3B5A-C265-01556EE9E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C1AF626-36BA-4CC2-1E92-1A73DAAD1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71584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474FA55-925D-B41E-155E-11C8E7231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4858A65-EF10-49B7-D969-2D5A22A1A4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8D63409-B356-8440-F30C-3B5734079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FE12DF-B2BD-AB9E-CD63-A283D22DE1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170412-6142-13F2-0FB5-F0B8FE9606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459788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22313A8-FBDD-5FD8-3688-4D13D7C8E1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475ACC7-E3C0-B3E3-AAEE-B801F361B8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969410D-7975-A2F2-4B90-2FD4B871EC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92A6F0D-73C2-ED5D-02A3-EC9EDA135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41B9FD1-75F6-09BF-1E66-E96B165561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BF7B5DD9-5DF7-9F38-340B-A10FF5AEF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82471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40A25F-F9AE-B785-FF29-8E250FA0A9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180A242-F05A-1ECA-22E6-C934BC197A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95ACE71-2B59-955D-1AD8-056D76B3F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C92C0FC-4E99-1DB7-A631-AE82630A17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62F3CE7-760F-8CD9-8F5A-5C2F54F4C5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4965B81-678B-9018-3CF7-FCACADE3C7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66DA42B-22FC-5E10-6066-7209C758F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4E358EA-9970-B726-13BC-2F73A4D59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52735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7CBBCA-881C-7D88-1DEF-0D6EDA6B9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3BDFC92-8FA7-3A6F-219B-676000B4E2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27D5FCA-50D6-319F-1C52-CEF62590A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88CBDBA8-5A08-DB6A-D6E6-F6B5A9858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4449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DD25781-7EEA-EE74-BF88-B47FF504F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98875B7-59A0-7FF9-07F2-73E4184254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FFC1B70-0406-747F-238C-4C785CBD3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52423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F1E535-B6AA-648E-3997-6541075B2A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714F82F-1670-C79A-3962-F91E2F95A5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18D42B8-E746-3724-6B94-2570407F95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0FDCE25-E3DD-5058-6E84-6803D97C9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AF983A9-3D9D-EDE9-37A3-ECB402332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164520B-4F4A-307D-CB14-968B98E75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985380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2F6C8F-80F7-B1CF-2FAA-14AEDDFDA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53AF86B-9B12-113F-7353-70AAB85DEE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5B9F31B-AA4D-E509-DB82-DD0A6A4694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F38C5C7-877C-CDE1-732A-19BD8C41E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35D0916-7B32-F6BC-14BE-9602FA877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2D8A1BC-5584-C911-0CB1-6AC58C290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800955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A0A8B6CA-CA0E-E18F-A3A0-07FBDD78BD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22FF3F5-2A5E-EC57-D20B-B098B6214F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3E02199-17D3-8B58-489D-1D28E3D914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F6EFED-A43C-4F91-AF23-CCB95ED2A150}" type="datetimeFigureOut">
              <a:rPr lang="it-IT" smtClean="0"/>
              <a:t>31/07/2024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8FE70F0-731F-FF66-1B35-6E1E00D754E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B124C2C-1E2E-F059-D680-846437397C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4642F5-E132-4D18-97EE-226B498E71F9}" type="slidenum">
              <a:rPr lang="it-IT" smtClean="0"/>
              <a:t>‹#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250735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19B67EC1-C7F1-DC0C-BC18-DBC076D629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4002736"/>
              </p:ext>
            </p:extLst>
          </p:nvPr>
        </p:nvGraphicFramePr>
        <p:xfrm>
          <a:off x="1124889" y="1317356"/>
          <a:ext cx="9942223" cy="4776139"/>
        </p:xfrm>
        <a:graphic>
          <a:graphicData uri="http://schemas.openxmlformats.org/drawingml/2006/table">
            <a:tbl>
              <a:tblPr/>
              <a:tblGrid>
                <a:gridCol w="910659">
                  <a:extLst>
                    <a:ext uri="{9D8B030D-6E8A-4147-A177-3AD203B41FA5}">
                      <a16:colId xmlns:a16="http://schemas.microsoft.com/office/drawing/2014/main" val="3769422704"/>
                    </a:ext>
                  </a:extLst>
                </a:gridCol>
                <a:gridCol w="862369">
                  <a:extLst>
                    <a:ext uri="{9D8B030D-6E8A-4147-A177-3AD203B41FA5}">
                      <a16:colId xmlns:a16="http://schemas.microsoft.com/office/drawing/2014/main" val="2698264430"/>
                    </a:ext>
                  </a:extLst>
                </a:gridCol>
                <a:gridCol w="755144">
                  <a:extLst>
                    <a:ext uri="{9D8B030D-6E8A-4147-A177-3AD203B41FA5}">
                      <a16:colId xmlns:a16="http://schemas.microsoft.com/office/drawing/2014/main" val="2685301923"/>
                    </a:ext>
                  </a:extLst>
                </a:gridCol>
                <a:gridCol w="949166">
                  <a:extLst>
                    <a:ext uri="{9D8B030D-6E8A-4147-A177-3AD203B41FA5}">
                      <a16:colId xmlns:a16="http://schemas.microsoft.com/office/drawing/2014/main" val="2925359212"/>
                    </a:ext>
                  </a:extLst>
                </a:gridCol>
                <a:gridCol w="705296">
                  <a:extLst>
                    <a:ext uri="{9D8B030D-6E8A-4147-A177-3AD203B41FA5}">
                      <a16:colId xmlns:a16="http://schemas.microsoft.com/office/drawing/2014/main" val="3507408852"/>
                    </a:ext>
                  </a:extLst>
                </a:gridCol>
                <a:gridCol w="771607">
                  <a:extLst>
                    <a:ext uri="{9D8B030D-6E8A-4147-A177-3AD203B41FA5}">
                      <a16:colId xmlns:a16="http://schemas.microsoft.com/office/drawing/2014/main" val="939822599"/>
                    </a:ext>
                  </a:extLst>
                </a:gridCol>
                <a:gridCol w="858962">
                  <a:extLst>
                    <a:ext uri="{9D8B030D-6E8A-4147-A177-3AD203B41FA5}">
                      <a16:colId xmlns:a16="http://schemas.microsoft.com/office/drawing/2014/main" val="3705272455"/>
                    </a:ext>
                  </a:extLst>
                </a:gridCol>
                <a:gridCol w="858962">
                  <a:extLst>
                    <a:ext uri="{9D8B030D-6E8A-4147-A177-3AD203B41FA5}">
                      <a16:colId xmlns:a16="http://schemas.microsoft.com/office/drawing/2014/main" val="161982964"/>
                    </a:ext>
                  </a:extLst>
                </a:gridCol>
                <a:gridCol w="858962">
                  <a:extLst>
                    <a:ext uri="{9D8B030D-6E8A-4147-A177-3AD203B41FA5}">
                      <a16:colId xmlns:a16="http://schemas.microsoft.com/office/drawing/2014/main" val="1200198797"/>
                    </a:ext>
                  </a:extLst>
                </a:gridCol>
                <a:gridCol w="858962">
                  <a:extLst>
                    <a:ext uri="{9D8B030D-6E8A-4147-A177-3AD203B41FA5}">
                      <a16:colId xmlns:a16="http://schemas.microsoft.com/office/drawing/2014/main" val="1290477952"/>
                    </a:ext>
                  </a:extLst>
                </a:gridCol>
                <a:gridCol w="1552134">
                  <a:extLst>
                    <a:ext uri="{9D8B030D-6E8A-4147-A177-3AD203B41FA5}">
                      <a16:colId xmlns:a16="http://schemas.microsoft.com/office/drawing/2014/main" val="3008850524"/>
                    </a:ext>
                  </a:extLst>
                </a:gridCol>
              </a:tblGrid>
              <a:tr h="178231">
                <a:tc>
                  <a:txBody>
                    <a:bodyPr/>
                    <a:lstStyle/>
                    <a:p>
                      <a:pPr algn="l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EENING QUESTION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 QUALITATIVE STUDIE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6493880"/>
                  </a:ext>
                </a:extLst>
              </a:tr>
              <a:tr h="650929">
                <a:tc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ID</a:t>
                      </a:r>
                      <a:endParaRPr lang="it-IT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rst autho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. Are there clear research questions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. Do the collected data allow to address the research questions?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. Is the qualitative approach appropriate to answer the research question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. Are the qualitative data collection methods adequate to address the research question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. Are the findings adequately derived from the data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. Is the interpretation of results sufficiently substantiated by data?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. Is there coherence between qualitative data sources, collection, analysis and interpretation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MENTS</a:t>
                      </a:r>
                    </a:p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510657"/>
                  </a:ext>
                </a:extLst>
              </a:tr>
              <a:tr h="30284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it-IT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guye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screeining criteria met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036193"/>
                  </a:ext>
                </a:extLst>
              </a:tr>
              <a:tr h="22684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gagn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study does not report data. It only explains the 3D printing process and the role 3D models can assume for complex aortic pathologies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63553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it-IT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ittl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screeining criteria met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9522826"/>
                  </a:ext>
                </a:extLst>
              </a:tr>
              <a:tr h="20873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les-Blac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study does not report data collection method and analysis. Data to support results are not reported. 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221054"/>
                  </a:ext>
                </a:extLst>
              </a:tr>
              <a:tr h="23264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rracc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study does not report data collection method and analysis. The interpretation of results is based mostly on surgeons opinions not collected with a specific metho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7704524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9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schwich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screeining criteria met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9167963"/>
                  </a:ext>
                </a:extLst>
              </a:tr>
              <a:tr h="1828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con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study does not report data analysis method. Results explanation is not supported by data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0968509"/>
                  </a:ext>
                </a:extLst>
              </a:tr>
              <a:tr h="27141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ortma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he study does not report data collection method and analysis. The interpretation of results is based mostly on opinions not collected with a specific metho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2613994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’Har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 screeining criteria met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056024"/>
                  </a:ext>
                </a:extLst>
              </a:tr>
            </a:tbl>
          </a:graphicData>
        </a:graphic>
      </p:graphicFrame>
      <p:sp>
        <p:nvSpPr>
          <p:cNvPr id="2" name="CasellaDiTesto 1">
            <a:extLst>
              <a:ext uri="{FF2B5EF4-FFF2-40B4-BE49-F238E27FC236}">
                <a16:creationId xmlns:a16="http://schemas.microsoft.com/office/drawing/2014/main" id="{16483452-FC56-48CE-B3A4-C8719A605E7C}"/>
              </a:ext>
            </a:extLst>
          </p:cNvPr>
          <p:cNvSpPr txBox="1"/>
          <p:nvPr/>
        </p:nvSpPr>
        <p:spPr>
          <a:xfrm>
            <a:off x="933253" y="499622"/>
            <a:ext cx="84841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Table S1</a:t>
            </a: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. Mixed Methods Appraisal Tool (MMAT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) to asses t</a:t>
            </a:r>
            <a:r>
              <a:rPr lang="en-US" sz="1800" dirty="0">
                <a:solidFill>
                  <a:srgbClr val="0D0D0D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e quality of studi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2256146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19B67EC1-C7F1-DC0C-BC18-DBC076D629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3357169"/>
              </p:ext>
            </p:extLst>
          </p:nvPr>
        </p:nvGraphicFramePr>
        <p:xfrm>
          <a:off x="1091401" y="1809546"/>
          <a:ext cx="10009198" cy="2249730"/>
        </p:xfrm>
        <a:graphic>
          <a:graphicData uri="http://schemas.openxmlformats.org/drawingml/2006/table">
            <a:tbl>
              <a:tblPr/>
              <a:tblGrid>
                <a:gridCol w="961693">
                  <a:extLst>
                    <a:ext uri="{9D8B030D-6E8A-4147-A177-3AD203B41FA5}">
                      <a16:colId xmlns:a16="http://schemas.microsoft.com/office/drawing/2014/main" val="3769422704"/>
                    </a:ext>
                  </a:extLst>
                </a:gridCol>
                <a:gridCol w="910697">
                  <a:extLst>
                    <a:ext uri="{9D8B030D-6E8A-4147-A177-3AD203B41FA5}">
                      <a16:colId xmlns:a16="http://schemas.microsoft.com/office/drawing/2014/main" val="2698264430"/>
                    </a:ext>
                  </a:extLst>
                </a:gridCol>
                <a:gridCol w="797463">
                  <a:extLst>
                    <a:ext uri="{9D8B030D-6E8A-4147-A177-3AD203B41FA5}">
                      <a16:colId xmlns:a16="http://schemas.microsoft.com/office/drawing/2014/main" val="2685301923"/>
                    </a:ext>
                  </a:extLst>
                </a:gridCol>
                <a:gridCol w="1002358">
                  <a:extLst>
                    <a:ext uri="{9D8B030D-6E8A-4147-A177-3AD203B41FA5}">
                      <a16:colId xmlns:a16="http://schemas.microsoft.com/office/drawing/2014/main" val="2925359212"/>
                    </a:ext>
                  </a:extLst>
                </a:gridCol>
                <a:gridCol w="744821">
                  <a:extLst>
                    <a:ext uri="{9D8B030D-6E8A-4147-A177-3AD203B41FA5}">
                      <a16:colId xmlns:a16="http://schemas.microsoft.com/office/drawing/2014/main" val="3507408852"/>
                    </a:ext>
                  </a:extLst>
                </a:gridCol>
                <a:gridCol w="814848">
                  <a:extLst>
                    <a:ext uri="{9D8B030D-6E8A-4147-A177-3AD203B41FA5}">
                      <a16:colId xmlns:a16="http://schemas.microsoft.com/office/drawing/2014/main" val="939822599"/>
                    </a:ext>
                  </a:extLst>
                </a:gridCol>
                <a:gridCol w="907099">
                  <a:extLst>
                    <a:ext uri="{9D8B030D-6E8A-4147-A177-3AD203B41FA5}">
                      <a16:colId xmlns:a16="http://schemas.microsoft.com/office/drawing/2014/main" val="3705272455"/>
                    </a:ext>
                  </a:extLst>
                </a:gridCol>
                <a:gridCol w="907099">
                  <a:extLst>
                    <a:ext uri="{9D8B030D-6E8A-4147-A177-3AD203B41FA5}">
                      <a16:colId xmlns:a16="http://schemas.microsoft.com/office/drawing/2014/main" val="161982964"/>
                    </a:ext>
                  </a:extLst>
                </a:gridCol>
                <a:gridCol w="907099">
                  <a:extLst>
                    <a:ext uri="{9D8B030D-6E8A-4147-A177-3AD203B41FA5}">
                      <a16:colId xmlns:a16="http://schemas.microsoft.com/office/drawing/2014/main" val="1200198797"/>
                    </a:ext>
                  </a:extLst>
                </a:gridCol>
                <a:gridCol w="907099">
                  <a:extLst>
                    <a:ext uri="{9D8B030D-6E8A-4147-A177-3AD203B41FA5}">
                      <a16:colId xmlns:a16="http://schemas.microsoft.com/office/drawing/2014/main" val="1290477952"/>
                    </a:ext>
                  </a:extLst>
                </a:gridCol>
                <a:gridCol w="1148922">
                  <a:extLst>
                    <a:ext uri="{9D8B030D-6E8A-4147-A177-3AD203B41FA5}">
                      <a16:colId xmlns:a16="http://schemas.microsoft.com/office/drawing/2014/main" val="3008850524"/>
                    </a:ext>
                  </a:extLst>
                </a:gridCol>
              </a:tblGrid>
              <a:tr h="185980">
                <a:tc>
                  <a:txBody>
                    <a:bodyPr/>
                    <a:lstStyle/>
                    <a:p>
                      <a:pPr algn="l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EENING QUESTION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 QUANTITATIVE DESCRIPTIVE STUDIE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6493880"/>
                  </a:ext>
                </a:extLst>
              </a:tr>
              <a:tr h="634505"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rst autho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. Are there clear research questions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. Do the collected data allow to address the research questions?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. Is the sampling strategy relevant to address the research question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. Is the sample representative of the target population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. Are the measurements appropriate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. Is the risk of nonresponse bias low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. Is the statistical analysis appropriate to answer the research question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MENTS</a:t>
                      </a:r>
                    </a:p>
                    <a:p>
                      <a:pPr algn="ctr" fontAlgn="t"/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510657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rest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ents and nonrespondents are not reported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036193"/>
                  </a:ext>
                </a:extLst>
              </a:tr>
              <a:tr h="22684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US" sz="15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it-IT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tyja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ents and nonrespondents are not reported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63553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it-IT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 ̈rkka ̈ine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ents and nonrespondents are not reported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9522826"/>
                  </a:ext>
                </a:extLst>
              </a:tr>
              <a:tr h="20873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’Reilly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700" b="0" i="0" u="none" strike="noStrike" noProof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spondents and nonrespondents are not reported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2210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39871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la 4">
            <a:extLst>
              <a:ext uri="{FF2B5EF4-FFF2-40B4-BE49-F238E27FC236}">
                <a16:creationId xmlns:a16="http://schemas.microsoft.com/office/drawing/2014/main" id="{19B67EC1-C7F1-DC0C-BC18-DBC076D629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0847453"/>
              </p:ext>
            </p:extLst>
          </p:nvPr>
        </p:nvGraphicFramePr>
        <p:xfrm>
          <a:off x="693207" y="1766807"/>
          <a:ext cx="10805587" cy="3915714"/>
        </p:xfrm>
        <a:graphic>
          <a:graphicData uri="http://schemas.openxmlformats.org/drawingml/2006/table">
            <a:tbl>
              <a:tblPr/>
              <a:tblGrid>
                <a:gridCol w="926533">
                  <a:extLst>
                    <a:ext uri="{9D8B030D-6E8A-4147-A177-3AD203B41FA5}">
                      <a16:colId xmlns:a16="http://schemas.microsoft.com/office/drawing/2014/main" val="3769422704"/>
                    </a:ext>
                  </a:extLst>
                </a:gridCol>
                <a:gridCol w="877402">
                  <a:extLst>
                    <a:ext uri="{9D8B030D-6E8A-4147-A177-3AD203B41FA5}">
                      <a16:colId xmlns:a16="http://schemas.microsoft.com/office/drawing/2014/main" val="2698264430"/>
                    </a:ext>
                  </a:extLst>
                </a:gridCol>
                <a:gridCol w="768307">
                  <a:extLst>
                    <a:ext uri="{9D8B030D-6E8A-4147-A177-3AD203B41FA5}">
                      <a16:colId xmlns:a16="http://schemas.microsoft.com/office/drawing/2014/main" val="2685301923"/>
                    </a:ext>
                  </a:extLst>
                </a:gridCol>
                <a:gridCol w="965712">
                  <a:extLst>
                    <a:ext uri="{9D8B030D-6E8A-4147-A177-3AD203B41FA5}">
                      <a16:colId xmlns:a16="http://schemas.microsoft.com/office/drawing/2014/main" val="2925359212"/>
                    </a:ext>
                  </a:extLst>
                </a:gridCol>
                <a:gridCol w="717591">
                  <a:extLst>
                    <a:ext uri="{9D8B030D-6E8A-4147-A177-3AD203B41FA5}">
                      <a16:colId xmlns:a16="http://schemas.microsoft.com/office/drawing/2014/main" val="3507408852"/>
                    </a:ext>
                  </a:extLst>
                </a:gridCol>
                <a:gridCol w="785057">
                  <a:extLst>
                    <a:ext uri="{9D8B030D-6E8A-4147-A177-3AD203B41FA5}">
                      <a16:colId xmlns:a16="http://schemas.microsoft.com/office/drawing/2014/main" val="939822599"/>
                    </a:ext>
                  </a:extLst>
                </a:gridCol>
                <a:gridCol w="873935">
                  <a:extLst>
                    <a:ext uri="{9D8B030D-6E8A-4147-A177-3AD203B41FA5}">
                      <a16:colId xmlns:a16="http://schemas.microsoft.com/office/drawing/2014/main" val="3705272455"/>
                    </a:ext>
                  </a:extLst>
                </a:gridCol>
                <a:gridCol w="873935">
                  <a:extLst>
                    <a:ext uri="{9D8B030D-6E8A-4147-A177-3AD203B41FA5}">
                      <a16:colId xmlns:a16="http://schemas.microsoft.com/office/drawing/2014/main" val="161982964"/>
                    </a:ext>
                  </a:extLst>
                </a:gridCol>
                <a:gridCol w="873935">
                  <a:extLst>
                    <a:ext uri="{9D8B030D-6E8A-4147-A177-3AD203B41FA5}">
                      <a16:colId xmlns:a16="http://schemas.microsoft.com/office/drawing/2014/main" val="1200198797"/>
                    </a:ext>
                  </a:extLst>
                </a:gridCol>
                <a:gridCol w="873935">
                  <a:extLst>
                    <a:ext uri="{9D8B030D-6E8A-4147-A177-3AD203B41FA5}">
                      <a16:colId xmlns:a16="http://schemas.microsoft.com/office/drawing/2014/main" val="1290477952"/>
                    </a:ext>
                  </a:extLst>
                </a:gridCol>
                <a:gridCol w="2269245">
                  <a:extLst>
                    <a:ext uri="{9D8B030D-6E8A-4147-A177-3AD203B41FA5}">
                      <a16:colId xmlns:a16="http://schemas.microsoft.com/office/drawing/2014/main" val="3008850524"/>
                    </a:ext>
                  </a:extLst>
                </a:gridCol>
              </a:tblGrid>
              <a:tr h="178231">
                <a:tc>
                  <a:txBody>
                    <a:bodyPr/>
                    <a:lstStyle/>
                    <a:p>
                      <a:pPr algn="l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it-IT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it-IT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CREENING QUESTION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it-IT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5">
                  <a:txBody>
                    <a:bodyPr/>
                    <a:lstStyle/>
                    <a:p>
                      <a:pPr algn="ctr" fontAlgn="t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 NON-RANDOMIZED STUDIE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t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6493880"/>
                  </a:ext>
                </a:extLst>
              </a:tr>
              <a:tr h="845928"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fID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irst autho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it-IT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ar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1. Are there clear research questions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2. Do the collected data allow to address the research questions?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. Are the participants representative of the target population?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2. Are measurements appropriate regarding both the outcome and intervention (or exposure)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. Are there complete outcome data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4. Are the confounders accounted for in the design and analysis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5. During the study period, is the intervention administered (or exposure occurred) as intended?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t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5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MENTS</a:t>
                      </a:r>
                    </a:p>
                    <a:p>
                      <a:pPr algn="ctr" fontAlgn="t"/>
                      <a:endParaRPr lang="en-US" sz="8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1510657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7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ufmann 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2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3036193"/>
                  </a:ext>
                </a:extLst>
              </a:tr>
              <a:tr h="226849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</a:t>
                      </a:r>
                      <a:endParaRPr lang="it-IT" sz="15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liewer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163553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GB" sz="1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8</a:t>
                      </a:r>
                      <a:endParaRPr lang="it-IT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öçer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29522826"/>
                  </a:ext>
                </a:extLst>
              </a:tr>
              <a:tr h="20873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2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rone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8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23221054"/>
                  </a:ext>
                </a:extLst>
              </a:tr>
              <a:tr h="23264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2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rr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7704524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her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9167963"/>
                  </a:ext>
                </a:extLst>
              </a:tr>
              <a:tr h="18288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m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6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0968509"/>
                  </a:ext>
                </a:extLst>
              </a:tr>
              <a:tr h="294662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aschwich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21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2613994"/>
                  </a:ext>
                </a:extLst>
              </a:tr>
              <a:tr h="20485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Bef>
                          <a:spcPts val="1200"/>
                        </a:spcBef>
                        <a:spcAft>
                          <a:spcPts val="300"/>
                        </a:spcAft>
                      </a:pPr>
                      <a:r>
                        <a:rPr lang="en-GB" sz="15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r>
                        <a:rPr lang="en-US" sz="150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it-IT" sz="15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hibata 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an't tell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Yes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B05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actors that predict the outcome and the intervention at baseline are not reported.</a:t>
                      </a:r>
                    </a:p>
                  </a:txBody>
                  <a:tcPr marL="6350" marR="6350" marT="635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6305602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51481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7</TotalTime>
  <Words>847</Words>
  <Application>Microsoft Office PowerPoint</Application>
  <PresentationFormat>Widescreen</PresentationFormat>
  <Paragraphs>28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ema di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rianna Mersanne</dc:creator>
  <cp:lastModifiedBy>MDPI</cp:lastModifiedBy>
  <cp:revision>12</cp:revision>
  <dcterms:created xsi:type="dcterms:W3CDTF">2024-04-30T14:04:10Z</dcterms:created>
  <dcterms:modified xsi:type="dcterms:W3CDTF">2024-07-31T10:50:41Z</dcterms:modified>
</cp:coreProperties>
</file>